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4AF97C2-58C6-417F-98D0-02F8F9986A1D}" type="doc">
      <dgm:prSet loTypeId="urn:microsoft.com/office/officeart/2005/8/layout/process3" loCatId="process" qsTypeId="urn:microsoft.com/office/officeart/2005/8/quickstyle/simple1" qsCatId="simple" csTypeId="urn:microsoft.com/office/officeart/2005/8/colors/colorful1" csCatId="colorful" phldr="1"/>
      <dgm:spPr/>
      <dgm:t>
        <a:bodyPr/>
        <a:lstStyle/>
        <a:p>
          <a:endParaRPr lang="en-US"/>
        </a:p>
      </dgm:t>
    </dgm:pt>
    <dgm:pt modelId="{37225B65-CFDC-423E-B303-EB071E5C0DB6}">
      <dgm:prSet phldrT="[Text]" custT="1"/>
      <dgm:spPr>
        <a:solidFill>
          <a:schemeClr val="tx1"/>
        </a:solidFill>
        <a:ln>
          <a:solidFill>
            <a:schemeClr val="tx1"/>
          </a:solidFill>
        </a:ln>
      </dgm:spPr>
      <dgm:t>
        <a:bodyPr/>
        <a:lstStyle/>
        <a:p>
          <a:pPr algn="r"/>
          <a:r>
            <a:rPr lang="en-US" sz="1800" dirty="0"/>
            <a:t>Stage 1: Information Gathering</a:t>
          </a:r>
        </a:p>
      </dgm:t>
    </dgm:pt>
    <dgm:pt modelId="{6E3B9348-E9E6-4766-888C-2C70C859DF15}" type="parTrans" cxnId="{B26F4418-57C5-487E-9770-B7716A9662BF}">
      <dgm:prSet/>
      <dgm:spPr/>
      <dgm:t>
        <a:bodyPr/>
        <a:lstStyle/>
        <a:p>
          <a:pPr algn="r"/>
          <a:endParaRPr lang="en-US"/>
        </a:p>
      </dgm:t>
    </dgm:pt>
    <dgm:pt modelId="{A893EB38-3EB2-488E-985C-A811EBC91DB8}" type="sibTrans" cxnId="{B26F4418-57C5-487E-9770-B7716A9662BF}">
      <dgm:prSet/>
      <dgm:spPr>
        <a:solidFill>
          <a:schemeClr val="tx1"/>
        </a:solidFill>
      </dgm:spPr>
      <dgm:t>
        <a:bodyPr/>
        <a:lstStyle/>
        <a:p>
          <a:pPr algn="r"/>
          <a:endParaRPr lang="en-US"/>
        </a:p>
      </dgm:t>
    </dgm:pt>
    <dgm:pt modelId="{6747797B-B899-44E5-AA3F-D3B8F1B1047F}">
      <dgm:prSet phldrT="[Text]" custT="1"/>
      <dgm:spPr>
        <a:ln>
          <a:solidFill>
            <a:schemeClr val="tx1"/>
          </a:solidFill>
        </a:ln>
      </dgm:spPr>
      <dgm:t>
        <a:bodyPr/>
        <a:lstStyle/>
        <a:p>
          <a:pPr algn="l"/>
          <a:r>
            <a:rPr lang="en-US" sz="1400" dirty="0"/>
            <a:t>Literature Review of dietary interventions in older adults</a:t>
          </a:r>
        </a:p>
      </dgm:t>
    </dgm:pt>
    <dgm:pt modelId="{7FF41D5F-8B72-41E1-8EF4-525AA0B40B47}" type="parTrans" cxnId="{046050E3-FB55-4F7F-806E-910C10396B31}">
      <dgm:prSet/>
      <dgm:spPr/>
      <dgm:t>
        <a:bodyPr/>
        <a:lstStyle/>
        <a:p>
          <a:pPr algn="r"/>
          <a:endParaRPr lang="en-US"/>
        </a:p>
      </dgm:t>
    </dgm:pt>
    <dgm:pt modelId="{0140ED0C-8D81-4754-9555-E2086B216733}" type="sibTrans" cxnId="{046050E3-FB55-4F7F-806E-910C10396B31}">
      <dgm:prSet/>
      <dgm:spPr/>
      <dgm:t>
        <a:bodyPr/>
        <a:lstStyle/>
        <a:p>
          <a:pPr algn="r"/>
          <a:endParaRPr lang="en-US"/>
        </a:p>
      </dgm:t>
    </dgm:pt>
    <dgm:pt modelId="{8C2D7B77-45D1-43D8-BBC3-A807DD536278}">
      <dgm:prSet phldrT="[Text]" custT="1"/>
      <dgm:spPr>
        <a:solidFill>
          <a:schemeClr val="tx1">
            <a:lumMod val="75000"/>
            <a:lumOff val="25000"/>
          </a:schemeClr>
        </a:solidFill>
      </dgm:spPr>
      <dgm:t>
        <a:bodyPr/>
        <a:lstStyle/>
        <a:p>
          <a:pPr algn="r"/>
          <a:r>
            <a:rPr lang="en-US" sz="1800" dirty="0"/>
            <a:t>Stage 2: Preliminary Adaption Design</a:t>
          </a:r>
        </a:p>
      </dgm:t>
    </dgm:pt>
    <dgm:pt modelId="{F4EAE35C-C309-4367-AC65-39F984A08A14}" type="parTrans" cxnId="{F170D1BE-7C16-4706-8F9B-1C8DDC9705AB}">
      <dgm:prSet/>
      <dgm:spPr/>
      <dgm:t>
        <a:bodyPr/>
        <a:lstStyle/>
        <a:p>
          <a:pPr algn="r"/>
          <a:endParaRPr lang="en-US"/>
        </a:p>
      </dgm:t>
    </dgm:pt>
    <dgm:pt modelId="{FC690BBA-9FBF-49B9-B3A4-EBB3FB2B87D2}" type="sibTrans" cxnId="{F170D1BE-7C16-4706-8F9B-1C8DDC9705AB}">
      <dgm:prSet/>
      <dgm:spPr>
        <a:solidFill>
          <a:schemeClr val="tx1">
            <a:lumMod val="75000"/>
            <a:lumOff val="25000"/>
          </a:schemeClr>
        </a:solidFill>
      </dgm:spPr>
      <dgm:t>
        <a:bodyPr/>
        <a:lstStyle/>
        <a:p>
          <a:pPr algn="r"/>
          <a:endParaRPr lang="en-US"/>
        </a:p>
      </dgm:t>
    </dgm:pt>
    <dgm:pt modelId="{9D877A12-259A-4C0F-97F6-D818F4CB978B}">
      <dgm:prSet phldrT="[Text]" custT="1"/>
      <dgm:spPr/>
      <dgm:t>
        <a:bodyPr/>
        <a:lstStyle/>
        <a:p>
          <a:pPr algn="l"/>
          <a:r>
            <a:rPr lang="en-US" sz="1400" dirty="0"/>
            <a:t>Incorporation of evidence-based behavioral techniques</a:t>
          </a:r>
        </a:p>
      </dgm:t>
    </dgm:pt>
    <dgm:pt modelId="{621661AE-6D8B-4157-9FD3-B356BF3CA2CA}" type="parTrans" cxnId="{4784A0EF-F85A-4FDA-970A-2754037286F8}">
      <dgm:prSet/>
      <dgm:spPr/>
      <dgm:t>
        <a:bodyPr/>
        <a:lstStyle/>
        <a:p>
          <a:pPr algn="r"/>
          <a:endParaRPr lang="en-US"/>
        </a:p>
      </dgm:t>
    </dgm:pt>
    <dgm:pt modelId="{1AFBB74E-274A-4BB3-9902-B779AE29210A}" type="sibTrans" cxnId="{4784A0EF-F85A-4FDA-970A-2754037286F8}">
      <dgm:prSet/>
      <dgm:spPr/>
      <dgm:t>
        <a:bodyPr/>
        <a:lstStyle/>
        <a:p>
          <a:pPr algn="r"/>
          <a:endParaRPr lang="en-US"/>
        </a:p>
      </dgm:t>
    </dgm:pt>
    <dgm:pt modelId="{A743DBA1-2F65-4049-97C1-7ECA5238837C}">
      <dgm:prSet phldrT="[Text]" custT="1"/>
      <dgm:spPr>
        <a:solidFill>
          <a:schemeClr val="tx1">
            <a:lumMod val="50000"/>
            <a:lumOff val="50000"/>
          </a:schemeClr>
        </a:solidFill>
      </dgm:spPr>
      <dgm:t>
        <a:bodyPr/>
        <a:lstStyle/>
        <a:p>
          <a:pPr algn="r"/>
          <a:r>
            <a:rPr lang="en-US" sz="1800" dirty="0"/>
            <a:t>Stage 3: Preliminary Adaptation Tests	</a:t>
          </a:r>
        </a:p>
      </dgm:t>
    </dgm:pt>
    <dgm:pt modelId="{07FDF71B-EC48-459C-8FB5-8394356553F3}" type="parTrans" cxnId="{9481CEF3-DA25-402D-A85B-C51B9CFF927A}">
      <dgm:prSet/>
      <dgm:spPr/>
      <dgm:t>
        <a:bodyPr/>
        <a:lstStyle/>
        <a:p>
          <a:pPr algn="r"/>
          <a:endParaRPr lang="en-US"/>
        </a:p>
      </dgm:t>
    </dgm:pt>
    <dgm:pt modelId="{D82AEE17-C8C5-459F-AE4F-01477B1C89DE}" type="sibTrans" cxnId="{9481CEF3-DA25-402D-A85B-C51B9CFF927A}">
      <dgm:prSet/>
      <dgm:spPr>
        <a:solidFill>
          <a:schemeClr val="tx1">
            <a:lumMod val="50000"/>
            <a:lumOff val="50000"/>
          </a:schemeClr>
        </a:solidFill>
      </dgm:spPr>
      <dgm:t>
        <a:bodyPr/>
        <a:lstStyle/>
        <a:p>
          <a:pPr algn="r"/>
          <a:endParaRPr lang="en-US"/>
        </a:p>
      </dgm:t>
    </dgm:pt>
    <dgm:pt modelId="{7371A46A-CCAB-41AB-B8FF-4BECF1054B53}">
      <dgm:prSet phldrT="[Text]" custT="1"/>
      <dgm:spPr>
        <a:ln>
          <a:solidFill>
            <a:schemeClr val="tx1">
              <a:lumMod val="50000"/>
              <a:lumOff val="50000"/>
            </a:schemeClr>
          </a:solidFill>
        </a:ln>
      </dgm:spPr>
      <dgm:t>
        <a:bodyPr/>
        <a:lstStyle/>
        <a:p>
          <a:pPr algn="l"/>
          <a:r>
            <a:rPr lang="en-US" sz="1400" dirty="0"/>
            <a:t>Iterative review of intervention materials and pilot testing phone-based intervention components</a:t>
          </a:r>
        </a:p>
      </dgm:t>
    </dgm:pt>
    <dgm:pt modelId="{4AA24F98-B016-4F69-B183-0E3AE822D62F}" type="parTrans" cxnId="{E40C78BF-5015-4AF4-9438-208A9FD6376A}">
      <dgm:prSet/>
      <dgm:spPr/>
      <dgm:t>
        <a:bodyPr/>
        <a:lstStyle/>
        <a:p>
          <a:pPr algn="r"/>
          <a:endParaRPr lang="en-US"/>
        </a:p>
      </dgm:t>
    </dgm:pt>
    <dgm:pt modelId="{30808386-5242-451F-A486-4DF7B45D02FD}" type="sibTrans" cxnId="{E40C78BF-5015-4AF4-9438-208A9FD6376A}">
      <dgm:prSet/>
      <dgm:spPr/>
      <dgm:t>
        <a:bodyPr/>
        <a:lstStyle/>
        <a:p>
          <a:pPr algn="r"/>
          <a:endParaRPr lang="en-US"/>
        </a:p>
      </dgm:t>
    </dgm:pt>
    <dgm:pt modelId="{9E4EAA69-09E2-4666-AD24-A9F989FD9977}">
      <dgm:prSet phldrT="[Text]" custT="1"/>
      <dgm:spPr>
        <a:ln>
          <a:solidFill>
            <a:schemeClr val="tx1"/>
          </a:solidFill>
        </a:ln>
      </dgm:spPr>
      <dgm:t>
        <a:bodyPr/>
        <a:lstStyle/>
        <a:p>
          <a:pPr algn="l"/>
          <a:r>
            <a:rPr lang="en-US" sz="1400" dirty="0"/>
            <a:t>Discussion Group with clinic staff and providers</a:t>
          </a:r>
        </a:p>
      </dgm:t>
    </dgm:pt>
    <dgm:pt modelId="{5B30A507-9201-48C2-AAE7-C7E19C979445}" type="parTrans" cxnId="{E9D5DF10-8B73-409D-81C0-49DD7CE49F83}">
      <dgm:prSet/>
      <dgm:spPr/>
      <dgm:t>
        <a:bodyPr/>
        <a:lstStyle/>
        <a:p>
          <a:pPr algn="r"/>
          <a:endParaRPr lang="en-US"/>
        </a:p>
      </dgm:t>
    </dgm:pt>
    <dgm:pt modelId="{8C13FB61-7CA4-4DC6-9937-A552E6B24AB2}" type="sibTrans" cxnId="{E9D5DF10-8B73-409D-81C0-49DD7CE49F83}">
      <dgm:prSet/>
      <dgm:spPr/>
      <dgm:t>
        <a:bodyPr/>
        <a:lstStyle/>
        <a:p>
          <a:pPr algn="r"/>
          <a:endParaRPr lang="en-US"/>
        </a:p>
      </dgm:t>
    </dgm:pt>
    <dgm:pt modelId="{6D7ED019-6E6E-404A-A7C2-51CCC754E0BE}">
      <dgm:prSet phldrT="[Text]" custT="1"/>
      <dgm:spPr>
        <a:ln>
          <a:solidFill>
            <a:schemeClr val="tx1"/>
          </a:solidFill>
        </a:ln>
      </dgm:spPr>
      <dgm:t>
        <a:bodyPr/>
        <a:lstStyle/>
        <a:p>
          <a:pPr algn="l"/>
          <a:r>
            <a:rPr lang="en-US" sz="1400" dirty="0"/>
            <a:t>In-Depth Interviews with NMIBC survivors</a:t>
          </a:r>
        </a:p>
      </dgm:t>
    </dgm:pt>
    <dgm:pt modelId="{3B7EB2F2-F43D-49F9-B724-1C5C5B510253}" type="parTrans" cxnId="{EB6200E2-D3CF-4F51-B457-B7B165BE912A}">
      <dgm:prSet/>
      <dgm:spPr/>
      <dgm:t>
        <a:bodyPr/>
        <a:lstStyle/>
        <a:p>
          <a:pPr algn="r"/>
          <a:endParaRPr lang="en-US"/>
        </a:p>
      </dgm:t>
    </dgm:pt>
    <dgm:pt modelId="{96D0803D-9B4B-43C9-A0FA-DC510623477B}" type="sibTrans" cxnId="{EB6200E2-D3CF-4F51-B457-B7B165BE912A}">
      <dgm:prSet/>
      <dgm:spPr/>
      <dgm:t>
        <a:bodyPr/>
        <a:lstStyle/>
        <a:p>
          <a:pPr algn="r"/>
          <a:endParaRPr lang="en-US"/>
        </a:p>
      </dgm:t>
    </dgm:pt>
    <dgm:pt modelId="{427270F1-C57C-4FD5-A326-C0C77D0ECC65}">
      <dgm:prSet custT="1"/>
      <dgm:spPr>
        <a:solidFill>
          <a:schemeClr val="bg2">
            <a:lumMod val="75000"/>
          </a:schemeClr>
        </a:solidFill>
      </dgm:spPr>
      <dgm:t>
        <a:bodyPr/>
        <a:lstStyle/>
        <a:p>
          <a:pPr algn="r"/>
          <a:r>
            <a:rPr lang="en-US" sz="1800" dirty="0"/>
            <a:t>Stage 4: Adaptation Refinement</a:t>
          </a:r>
        </a:p>
      </dgm:t>
    </dgm:pt>
    <dgm:pt modelId="{D5868032-E724-4A01-8FBD-A3F7B06E2EB0}" type="parTrans" cxnId="{21AC3122-55DC-4A03-983F-992E72D4EC5D}">
      <dgm:prSet/>
      <dgm:spPr/>
      <dgm:t>
        <a:bodyPr/>
        <a:lstStyle/>
        <a:p>
          <a:pPr algn="r"/>
          <a:endParaRPr lang="en-US"/>
        </a:p>
      </dgm:t>
    </dgm:pt>
    <dgm:pt modelId="{0178D630-006E-4F44-AD0C-B397EA714A75}" type="sibTrans" cxnId="{21AC3122-55DC-4A03-983F-992E72D4EC5D}">
      <dgm:prSet/>
      <dgm:spPr/>
      <dgm:t>
        <a:bodyPr/>
        <a:lstStyle/>
        <a:p>
          <a:pPr algn="r"/>
          <a:endParaRPr lang="en-US"/>
        </a:p>
      </dgm:t>
    </dgm:pt>
    <dgm:pt modelId="{ED45B463-6755-46F3-A13E-1DE0376C2153}">
      <dgm:prSet phldrT="[Text]" custT="1"/>
      <dgm:spPr/>
      <dgm:t>
        <a:bodyPr/>
        <a:lstStyle/>
        <a:p>
          <a:pPr algn="l"/>
          <a:r>
            <a:rPr lang="en-US" sz="1400" dirty="0"/>
            <a:t>Integrated intervention strategies from PEN-3 Model analyses and qualitative results (Table 2)</a:t>
          </a:r>
        </a:p>
      </dgm:t>
    </dgm:pt>
    <dgm:pt modelId="{5FBC1F8D-C27B-4906-A556-27D5ED06F853}" type="parTrans" cxnId="{14B94DEB-E338-4039-962D-604FDA2E8E7C}">
      <dgm:prSet/>
      <dgm:spPr/>
      <dgm:t>
        <a:bodyPr/>
        <a:lstStyle/>
        <a:p>
          <a:pPr algn="r"/>
          <a:endParaRPr lang="en-US"/>
        </a:p>
      </dgm:t>
    </dgm:pt>
    <dgm:pt modelId="{14CDA06D-2B95-4C15-9519-CC8407C6AE55}" type="sibTrans" cxnId="{14B94DEB-E338-4039-962D-604FDA2E8E7C}">
      <dgm:prSet/>
      <dgm:spPr/>
      <dgm:t>
        <a:bodyPr/>
        <a:lstStyle/>
        <a:p>
          <a:pPr algn="r"/>
          <a:endParaRPr lang="en-US"/>
        </a:p>
      </dgm:t>
    </dgm:pt>
    <dgm:pt modelId="{DB198817-39C9-4A6E-B3F9-5C765293B054}">
      <dgm:prSet custT="1"/>
      <dgm:spPr>
        <a:ln>
          <a:solidFill>
            <a:schemeClr val="bg2">
              <a:lumMod val="75000"/>
            </a:schemeClr>
          </a:solidFill>
        </a:ln>
      </dgm:spPr>
      <dgm:t>
        <a:bodyPr/>
        <a:lstStyle/>
        <a:p>
          <a:pPr algn="l"/>
          <a:r>
            <a:rPr lang="en-US" sz="1400" dirty="0"/>
            <a:t>Final review of intervention products before intervention delivery, resulting in the POW-R Health Intervention   </a:t>
          </a:r>
        </a:p>
      </dgm:t>
    </dgm:pt>
    <dgm:pt modelId="{E0E070D8-0A1F-41DB-BC92-6A2454729E27}" type="parTrans" cxnId="{9B102633-088A-4E65-91C9-C01B54E498EF}">
      <dgm:prSet/>
      <dgm:spPr/>
      <dgm:t>
        <a:bodyPr/>
        <a:lstStyle/>
        <a:p>
          <a:pPr algn="r"/>
          <a:endParaRPr lang="en-US"/>
        </a:p>
      </dgm:t>
    </dgm:pt>
    <dgm:pt modelId="{A434C1EA-6155-475B-98D6-0283CC9040AD}" type="sibTrans" cxnId="{9B102633-088A-4E65-91C9-C01B54E498EF}">
      <dgm:prSet/>
      <dgm:spPr/>
      <dgm:t>
        <a:bodyPr/>
        <a:lstStyle/>
        <a:p>
          <a:pPr algn="r"/>
          <a:endParaRPr lang="en-US"/>
        </a:p>
      </dgm:t>
    </dgm:pt>
    <dgm:pt modelId="{72E5E352-CB8E-4B2D-BE9C-560EECB9C3CE}">
      <dgm:prSet phldrT="[Text]" custT="1"/>
      <dgm:spPr/>
      <dgm:t>
        <a:bodyPr/>
        <a:lstStyle/>
        <a:p>
          <a:pPr algn="l"/>
          <a:r>
            <a:rPr lang="en-US" sz="1400" dirty="0"/>
            <a:t>Grounded intervention in Social Cognitive Theory</a:t>
          </a:r>
        </a:p>
      </dgm:t>
    </dgm:pt>
    <dgm:pt modelId="{4BC63948-24BD-4448-98CA-838DF82D3ED5}" type="parTrans" cxnId="{2F2698F5-7505-4678-8A56-3BF7613C6A20}">
      <dgm:prSet/>
      <dgm:spPr/>
      <dgm:t>
        <a:bodyPr/>
        <a:lstStyle/>
        <a:p>
          <a:pPr algn="r"/>
          <a:endParaRPr lang="en-US"/>
        </a:p>
      </dgm:t>
    </dgm:pt>
    <dgm:pt modelId="{59EF8D98-7F2B-4D50-A8EA-04B69B2FAC27}" type="sibTrans" cxnId="{2F2698F5-7505-4678-8A56-3BF7613C6A20}">
      <dgm:prSet/>
      <dgm:spPr/>
      <dgm:t>
        <a:bodyPr/>
        <a:lstStyle/>
        <a:p>
          <a:pPr algn="r"/>
          <a:endParaRPr lang="en-US"/>
        </a:p>
      </dgm:t>
    </dgm:pt>
    <dgm:pt modelId="{8C9D435A-6906-4FE5-80FF-436A97972A64}" type="pres">
      <dgm:prSet presAssocID="{84AF97C2-58C6-417F-98D0-02F8F9986A1D}" presName="linearFlow" presStyleCnt="0">
        <dgm:presLayoutVars>
          <dgm:dir/>
          <dgm:animLvl val="lvl"/>
          <dgm:resizeHandles val="exact"/>
        </dgm:presLayoutVars>
      </dgm:prSet>
      <dgm:spPr/>
    </dgm:pt>
    <dgm:pt modelId="{2E1443A1-8847-432A-83C4-2C46945FBC26}" type="pres">
      <dgm:prSet presAssocID="{37225B65-CFDC-423E-B303-EB071E5C0DB6}" presName="composite" presStyleCnt="0"/>
      <dgm:spPr/>
    </dgm:pt>
    <dgm:pt modelId="{06A43DF9-A45E-4542-8938-1AFF65968571}" type="pres">
      <dgm:prSet presAssocID="{37225B65-CFDC-423E-B303-EB071E5C0DB6}" presName="parTx" presStyleLbl="node1" presStyleIdx="0" presStyleCnt="4">
        <dgm:presLayoutVars>
          <dgm:chMax val="0"/>
          <dgm:chPref val="0"/>
          <dgm:bulletEnabled val="1"/>
        </dgm:presLayoutVars>
      </dgm:prSet>
      <dgm:spPr/>
    </dgm:pt>
    <dgm:pt modelId="{9D94E0DF-D093-451A-BA94-245F4E25FF6E}" type="pres">
      <dgm:prSet presAssocID="{37225B65-CFDC-423E-B303-EB071E5C0DB6}" presName="parSh" presStyleLbl="node1" presStyleIdx="0" presStyleCnt="4" custScaleX="82790" custLinFactNeighborY="-13402"/>
      <dgm:spPr/>
    </dgm:pt>
    <dgm:pt modelId="{917C1247-217C-4F7D-A008-0C6DBB91F0AA}" type="pres">
      <dgm:prSet presAssocID="{37225B65-CFDC-423E-B303-EB071E5C0DB6}" presName="desTx" presStyleLbl="fgAcc1" presStyleIdx="0" presStyleCnt="4" custScaleY="84979" custLinFactNeighborX="-9692" custLinFactNeighborY="-5946">
        <dgm:presLayoutVars>
          <dgm:bulletEnabled val="1"/>
        </dgm:presLayoutVars>
      </dgm:prSet>
      <dgm:spPr/>
    </dgm:pt>
    <dgm:pt modelId="{51ABA5FE-6BEC-424A-98E2-BBAFFB97CB9A}" type="pres">
      <dgm:prSet presAssocID="{A893EB38-3EB2-488E-985C-A811EBC91DB8}" presName="sibTrans" presStyleLbl="sibTrans2D1" presStyleIdx="0" presStyleCnt="3" custScaleX="165254" custLinFactNeighborX="-13520" custLinFactNeighborY="8211"/>
      <dgm:spPr/>
    </dgm:pt>
    <dgm:pt modelId="{0DCF4D41-817E-412D-AEA1-CC5CD6F080DF}" type="pres">
      <dgm:prSet presAssocID="{A893EB38-3EB2-488E-985C-A811EBC91DB8}" presName="connTx" presStyleLbl="sibTrans2D1" presStyleIdx="0" presStyleCnt="3"/>
      <dgm:spPr/>
    </dgm:pt>
    <dgm:pt modelId="{DF24F8F6-FE6F-4EBE-9878-BA60388BAC98}" type="pres">
      <dgm:prSet presAssocID="{8C2D7B77-45D1-43D8-BBC3-A807DD536278}" presName="composite" presStyleCnt="0"/>
      <dgm:spPr/>
    </dgm:pt>
    <dgm:pt modelId="{B5D3592F-7899-4513-B6EE-2D08F22B2D9C}" type="pres">
      <dgm:prSet presAssocID="{8C2D7B77-45D1-43D8-BBC3-A807DD536278}" presName="parTx" presStyleLbl="node1" presStyleIdx="0" presStyleCnt="4">
        <dgm:presLayoutVars>
          <dgm:chMax val="0"/>
          <dgm:chPref val="0"/>
          <dgm:bulletEnabled val="1"/>
        </dgm:presLayoutVars>
      </dgm:prSet>
      <dgm:spPr/>
    </dgm:pt>
    <dgm:pt modelId="{74989205-42F1-4AC8-B701-B632D7FEE30C}" type="pres">
      <dgm:prSet presAssocID="{8C2D7B77-45D1-43D8-BBC3-A807DD536278}" presName="parSh" presStyleLbl="node1" presStyleIdx="1" presStyleCnt="4" custScaleX="101169" custLinFactNeighborX="45990" custLinFactNeighborY="-10889"/>
      <dgm:spPr/>
    </dgm:pt>
    <dgm:pt modelId="{F6B44B51-1360-45F1-888A-55A538C8C211}" type="pres">
      <dgm:prSet presAssocID="{8C2D7B77-45D1-43D8-BBC3-A807DD536278}" presName="desTx" presStyleLbl="fgAcc1" presStyleIdx="1" presStyleCnt="4" custScaleY="85971" custLinFactNeighborX="33560" custLinFactNeighborY="-5322">
        <dgm:presLayoutVars>
          <dgm:bulletEnabled val="1"/>
        </dgm:presLayoutVars>
      </dgm:prSet>
      <dgm:spPr/>
    </dgm:pt>
    <dgm:pt modelId="{00181115-EF53-4153-AFF5-C35CEB2851D7}" type="pres">
      <dgm:prSet presAssocID="{FC690BBA-9FBF-49B9-B3A4-EBB3FB2B87D2}" presName="sibTrans" presStyleLbl="sibTrans2D1" presStyleIdx="1" presStyleCnt="3" custScaleX="164777" custLinFactNeighborX="-7618" custLinFactNeighborY="9139"/>
      <dgm:spPr/>
    </dgm:pt>
    <dgm:pt modelId="{311B592D-FB73-491B-ADC8-6E2543AB2FC3}" type="pres">
      <dgm:prSet presAssocID="{FC690BBA-9FBF-49B9-B3A4-EBB3FB2B87D2}" presName="connTx" presStyleLbl="sibTrans2D1" presStyleIdx="1" presStyleCnt="3"/>
      <dgm:spPr/>
    </dgm:pt>
    <dgm:pt modelId="{EEC457B4-8AA4-4A0C-A1CB-16FD2A5B667F}" type="pres">
      <dgm:prSet presAssocID="{A743DBA1-2F65-4049-97C1-7ECA5238837C}" presName="composite" presStyleCnt="0"/>
      <dgm:spPr/>
    </dgm:pt>
    <dgm:pt modelId="{9832D3FC-FCDE-4DA9-8E76-7B2714338FE1}" type="pres">
      <dgm:prSet presAssocID="{A743DBA1-2F65-4049-97C1-7ECA5238837C}" presName="parTx" presStyleLbl="node1" presStyleIdx="1" presStyleCnt="4">
        <dgm:presLayoutVars>
          <dgm:chMax val="0"/>
          <dgm:chPref val="0"/>
          <dgm:bulletEnabled val="1"/>
        </dgm:presLayoutVars>
      </dgm:prSet>
      <dgm:spPr/>
    </dgm:pt>
    <dgm:pt modelId="{ACB06B7E-B6E7-4D8E-BAFB-837050603E17}" type="pres">
      <dgm:prSet presAssocID="{A743DBA1-2F65-4049-97C1-7ECA5238837C}" presName="parSh" presStyleLbl="node1" presStyleIdx="2" presStyleCnt="4" custScaleX="93386" custLinFactNeighborX="5179" custLinFactNeighborY="-32667"/>
      <dgm:spPr/>
    </dgm:pt>
    <dgm:pt modelId="{74F4E7DC-FF92-4C0E-A9C4-6EC6F3B4479C}" type="pres">
      <dgm:prSet presAssocID="{A743DBA1-2F65-4049-97C1-7ECA5238837C}" presName="desTx" presStyleLbl="fgAcc1" presStyleIdx="2" presStyleCnt="4" custScaleY="48645" custLinFactNeighborX="-5729" custLinFactNeighborY="-24393">
        <dgm:presLayoutVars>
          <dgm:bulletEnabled val="1"/>
        </dgm:presLayoutVars>
      </dgm:prSet>
      <dgm:spPr/>
    </dgm:pt>
    <dgm:pt modelId="{F9273A91-9601-40FB-A9D2-4F082CD5BD3F}" type="pres">
      <dgm:prSet presAssocID="{D82AEE17-C8C5-459F-AE4F-01477B1C89DE}" presName="sibTrans" presStyleLbl="sibTrans2D1" presStyleIdx="2" presStyleCnt="3" custScaleX="161820" custLinFactNeighborX="-6325" custLinFactNeighborY="11627"/>
      <dgm:spPr/>
    </dgm:pt>
    <dgm:pt modelId="{3E64A7D6-9D26-448F-AA22-D0C5BE1A2CEB}" type="pres">
      <dgm:prSet presAssocID="{D82AEE17-C8C5-459F-AE4F-01477B1C89DE}" presName="connTx" presStyleLbl="sibTrans2D1" presStyleIdx="2" presStyleCnt="3"/>
      <dgm:spPr/>
    </dgm:pt>
    <dgm:pt modelId="{04DF62D2-E0D6-4640-AE15-641B54766C48}" type="pres">
      <dgm:prSet presAssocID="{427270F1-C57C-4FD5-A326-C0C77D0ECC65}" presName="composite" presStyleCnt="0"/>
      <dgm:spPr/>
    </dgm:pt>
    <dgm:pt modelId="{2CD7734F-57C3-4F5C-9B14-25FB2F8929C3}" type="pres">
      <dgm:prSet presAssocID="{427270F1-C57C-4FD5-A326-C0C77D0ECC65}" presName="parTx" presStyleLbl="node1" presStyleIdx="2" presStyleCnt="4">
        <dgm:presLayoutVars>
          <dgm:chMax val="0"/>
          <dgm:chPref val="0"/>
          <dgm:bulletEnabled val="1"/>
        </dgm:presLayoutVars>
      </dgm:prSet>
      <dgm:spPr/>
    </dgm:pt>
    <dgm:pt modelId="{D3123666-A23F-46C6-8F81-010D263DA991}" type="pres">
      <dgm:prSet presAssocID="{427270F1-C57C-4FD5-A326-C0C77D0ECC65}" presName="parSh" presStyleLbl="node1" presStyleIdx="3" presStyleCnt="4" custScaleX="84259" custLinFactNeighborX="-28621" custLinFactNeighborY="-34343"/>
      <dgm:spPr/>
    </dgm:pt>
    <dgm:pt modelId="{BEE2EF34-85E5-478B-BBE5-3640567F4C03}" type="pres">
      <dgm:prSet presAssocID="{427270F1-C57C-4FD5-A326-C0C77D0ECC65}" presName="desTx" presStyleLbl="fgAcc1" presStyleIdx="3" presStyleCnt="4" custScaleY="52591" custLinFactNeighborX="-35726" custLinFactNeighborY="-19961">
        <dgm:presLayoutVars>
          <dgm:bulletEnabled val="1"/>
        </dgm:presLayoutVars>
      </dgm:prSet>
      <dgm:spPr/>
    </dgm:pt>
  </dgm:ptLst>
  <dgm:cxnLst>
    <dgm:cxn modelId="{C3E22805-6D6E-4A4B-AD15-C1005986CFA9}" type="presOf" srcId="{9D877A12-259A-4C0F-97F6-D818F4CB978B}" destId="{F6B44B51-1360-45F1-888A-55A538C8C211}" srcOrd="0" destOrd="0" presId="urn:microsoft.com/office/officeart/2005/8/layout/process3"/>
    <dgm:cxn modelId="{E9D5DF10-8B73-409D-81C0-49DD7CE49F83}" srcId="{37225B65-CFDC-423E-B303-EB071E5C0DB6}" destId="{9E4EAA69-09E2-4666-AD24-A9F989FD9977}" srcOrd="1" destOrd="0" parTransId="{5B30A507-9201-48C2-AAE7-C7E19C979445}" sibTransId="{8C13FB61-7CA4-4DC6-9937-A552E6B24AB2}"/>
    <dgm:cxn modelId="{DCB5CD11-074C-47F8-94DB-971CCED4966F}" type="presOf" srcId="{6747797B-B899-44E5-AA3F-D3B8F1B1047F}" destId="{917C1247-217C-4F7D-A008-0C6DBB91F0AA}" srcOrd="0" destOrd="0" presId="urn:microsoft.com/office/officeart/2005/8/layout/process3"/>
    <dgm:cxn modelId="{B26F4418-57C5-487E-9770-B7716A9662BF}" srcId="{84AF97C2-58C6-417F-98D0-02F8F9986A1D}" destId="{37225B65-CFDC-423E-B303-EB071E5C0DB6}" srcOrd="0" destOrd="0" parTransId="{6E3B9348-E9E6-4766-888C-2C70C859DF15}" sibTransId="{A893EB38-3EB2-488E-985C-A811EBC91DB8}"/>
    <dgm:cxn modelId="{21AC3122-55DC-4A03-983F-992E72D4EC5D}" srcId="{84AF97C2-58C6-417F-98D0-02F8F9986A1D}" destId="{427270F1-C57C-4FD5-A326-C0C77D0ECC65}" srcOrd="3" destOrd="0" parTransId="{D5868032-E724-4A01-8FBD-A3F7B06E2EB0}" sibTransId="{0178D630-006E-4F44-AD0C-B397EA714A75}"/>
    <dgm:cxn modelId="{4619242A-A213-43ED-B5B7-80856EF7EC00}" type="presOf" srcId="{A743DBA1-2F65-4049-97C1-7ECA5238837C}" destId="{ACB06B7E-B6E7-4D8E-BAFB-837050603E17}" srcOrd="1" destOrd="0" presId="urn:microsoft.com/office/officeart/2005/8/layout/process3"/>
    <dgm:cxn modelId="{6513A731-2D03-4924-9368-AD6324BD6C8D}" type="presOf" srcId="{37225B65-CFDC-423E-B303-EB071E5C0DB6}" destId="{9D94E0DF-D093-451A-BA94-245F4E25FF6E}" srcOrd="1" destOrd="0" presId="urn:microsoft.com/office/officeart/2005/8/layout/process3"/>
    <dgm:cxn modelId="{D919E231-6CB8-4719-8266-6B0431CC17A7}" type="presOf" srcId="{6D7ED019-6E6E-404A-A7C2-51CCC754E0BE}" destId="{917C1247-217C-4F7D-A008-0C6DBB91F0AA}" srcOrd="0" destOrd="2" presId="urn:microsoft.com/office/officeart/2005/8/layout/process3"/>
    <dgm:cxn modelId="{9B102633-088A-4E65-91C9-C01B54E498EF}" srcId="{427270F1-C57C-4FD5-A326-C0C77D0ECC65}" destId="{DB198817-39C9-4A6E-B3F9-5C765293B054}" srcOrd="0" destOrd="0" parTransId="{E0E070D8-0A1F-41DB-BC92-6A2454729E27}" sibTransId="{A434C1EA-6155-475B-98D6-0283CC9040AD}"/>
    <dgm:cxn modelId="{FCD0854A-463F-481A-9BCC-3F66C563EA1A}" type="presOf" srcId="{427270F1-C57C-4FD5-A326-C0C77D0ECC65}" destId="{2CD7734F-57C3-4F5C-9B14-25FB2F8929C3}" srcOrd="0" destOrd="0" presId="urn:microsoft.com/office/officeart/2005/8/layout/process3"/>
    <dgm:cxn modelId="{82689D6A-0CD6-4046-BBBC-57C01DED9BE2}" type="presOf" srcId="{D82AEE17-C8C5-459F-AE4F-01477B1C89DE}" destId="{F9273A91-9601-40FB-A9D2-4F082CD5BD3F}" srcOrd="0" destOrd="0" presId="urn:microsoft.com/office/officeart/2005/8/layout/process3"/>
    <dgm:cxn modelId="{3DC0BF70-890F-4E59-8332-47295D99CAA0}" type="presOf" srcId="{8C2D7B77-45D1-43D8-BBC3-A807DD536278}" destId="{B5D3592F-7899-4513-B6EE-2D08F22B2D9C}" srcOrd="0" destOrd="0" presId="urn:microsoft.com/office/officeart/2005/8/layout/process3"/>
    <dgm:cxn modelId="{7572AB74-F142-4DA4-B039-48B79A332DA4}" type="presOf" srcId="{FC690BBA-9FBF-49B9-B3A4-EBB3FB2B87D2}" destId="{00181115-EF53-4153-AFF5-C35CEB2851D7}" srcOrd="0" destOrd="0" presId="urn:microsoft.com/office/officeart/2005/8/layout/process3"/>
    <dgm:cxn modelId="{1CF2E554-A4D7-43EC-81F3-ABE62B4248AB}" type="presOf" srcId="{427270F1-C57C-4FD5-A326-C0C77D0ECC65}" destId="{D3123666-A23F-46C6-8F81-010D263DA991}" srcOrd="1" destOrd="0" presId="urn:microsoft.com/office/officeart/2005/8/layout/process3"/>
    <dgm:cxn modelId="{1D0AA076-B506-4A84-9CBF-CF9D1F04F9C1}" type="presOf" srcId="{A743DBA1-2F65-4049-97C1-7ECA5238837C}" destId="{9832D3FC-FCDE-4DA9-8E76-7B2714338FE1}" srcOrd="0" destOrd="0" presId="urn:microsoft.com/office/officeart/2005/8/layout/process3"/>
    <dgm:cxn modelId="{C871CC77-74FB-43FC-A667-F62E2883FBC0}" type="presOf" srcId="{84AF97C2-58C6-417F-98D0-02F8F9986A1D}" destId="{8C9D435A-6906-4FE5-80FF-436A97972A64}" srcOrd="0" destOrd="0" presId="urn:microsoft.com/office/officeart/2005/8/layout/process3"/>
    <dgm:cxn modelId="{0097C18F-C841-47F5-9536-62DAE57C78CB}" type="presOf" srcId="{FC690BBA-9FBF-49B9-B3A4-EBB3FB2B87D2}" destId="{311B592D-FB73-491B-ADC8-6E2543AB2FC3}" srcOrd="1" destOrd="0" presId="urn:microsoft.com/office/officeart/2005/8/layout/process3"/>
    <dgm:cxn modelId="{72F2B195-6EA3-436C-8C3D-53FD8036C7FB}" type="presOf" srcId="{A893EB38-3EB2-488E-985C-A811EBC91DB8}" destId="{0DCF4D41-817E-412D-AEA1-CC5CD6F080DF}" srcOrd="1" destOrd="0" presId="urn:microsoft.com/office/officeart/2005/8/layout/process3"/>
    <dgm:cxn modelId="{55DD84A2-AA93-459A-834C-54805D31DFB6}" type="presOf" srcId="{D82AEE17-C8C5-459F-AE4F-01477B1C89DE}" destId="{3E64A7D6-9D26-448F-AA22-D0C5BE1A2CEB}" srcOrd="1" destOrd="0" presId="urn:microsoft.com/office/officeart/2005/8/layout/process3"/>
    <dgm:cxn modelId="{096993A6-7C62-4EFF-ADBA-A8408886020E}" type="presOf" srcId="{72E5E352-CB8E-4B2D-BE9C-560EECB9C3CE}" destId="{F6B44B51-1360-45F1-888A-55A538C8C211}" srcOrd="0" destOrd="1" presId="urn:microsoft.com/office/officeart/2005/8/layout/process3"/>
    <dgm:cxn modelId="{59A214B5-EDCA-4C91-B75F-8F871AA8A848}" type="presOf" srcId="{37225B65-CFDC-423E-B303-EB071E5C0DB6}" destId="{06A43DF9-A45E-4542-8938-1AFF65968571}" srcOrd="0" destOrd="0" presId="urn:microsoft.com/office/officeart/2005/8/layout/process3"/>
    <dgm:cxn modelId="{F170D1BE-7C16-4706-8F9B-1C8DDC9705AB}" srcId="{84AF97C2-58C6-417F-98D0-02F8F9986A1D}" destId="{8C2D7B77-45D1-43D8-BBC3-A807DD536278}" srcOrd="1" destOrd="0" parTransId="{F4EAE35C-C309-4367-AC65-39F984A08A14}" sibTransId="{FC690BBA-9FBF-49B9-B3A4-EBB3FB2B87D2}"/>
    <dgm:cxn modelId="{E40C78BF-5015-4AF4-9438-208A9FD6376A}" srcId="{A743DBA1-2F65-4049-97C1-7ECA5238837C}" destId="{7371A46A-CCAB-41AB-B8FF-4BECF1054B53}" srcOrd="0" destOrd="0" parTransId="{4AA24F98-B016-4F69-B183-0E3AE822D62F}" sibTransId="{30808386-5242-451F-A486-4DF7B45D02FD}"/>
    <dgm:cxn modelId="{1B8FF8C6-9175-44BD-A7C5-0FE3D6AFBCDD}" type="presOf" srcId="{DB198817-39C9-4A6E-B3F9-5C765293B054}" destId="{BEE2EF34-85E5-478B-BBE5-3640567F4C03}" srcOrd="0" destOrd="0" presId="urn:microsoft.com/office/officeart/2005/8/layout/process3"/>
    <dgm:cxn modelId="{E51B68CC-9BD8-4E9E-B263-DF34B85BE374}" type="presOf" srcId="{9E4EAA69-09E2-4666-AD24-A9F989FD9977}" destId="{917C1247-217C-4F7D-A008-0C6DBB91F0AA}" srcOrd="0" destOrd="1" presId="urn:microsoft.com/office/officeart/2005/8/layout/process3"/>
    <dgm:cxn modelId="{CE6C49D4-9A7E-4882-8283-D5F673F88755}" type="presOf" srcId="{7371A46A-CCAB-41AB-B8FF-4BECF1054B53}" destId="{74F4E7DC-FF92-4C0E-A9C4-6EC6F3B4479C}" srcOrd="0" destOrd="0" presId="urn:microsoft.com/office/officeart/2005/8/layout/process3"/>
    <dgm:cxn modelId="{B3CFC3D9-724D-4060-BFD9-F6F6CD088A96}" type="presOf" srcId="{ED45B463-6755-46F3-A13E-1DE0376C2153}" destId="{F6B44B51-1360-45F1-888A-55A538C8C211}" srcOrd="0" destOrd="2" presId="urn:microsoft.com/office/officeart/2005/8/layout/process3"/>
    <dgm:cxn modelId="{411865DA-DE72-44AE-95CF-387C946568F2}" type="presOf" srcId="{A893EB38-3EB2-488E-985C-A811EBC91DB8}" destId="{51ABA5FE-6BEC-424A-98E2-BBAFFB97CB9A}" srcOrd="0" destOrd="0" presId="urn:microsoft.com/office/officeart/2005/8/layout/process3"/>
    <dgm:cxn modelId="{D50B80DD-4167-4B9A-9304-910F44D359F4}" type="presOf" srcId="{8C2D7B77-45D1-43D8-BBC3-A807DD536278}" destId="{74989205-42F1-4AC8-B701-B632D7FEE30C}" srcOrd="1" destOrd="0" presId="urn:microsoft.com/office/officeart/2005/8/layout/process3"/>
    <dgm:cxn modelId="{EB6200E2-D3CF-4F51-B457-B7B165BE912A}" srcId="{37225B65-CFDC-423E-B303-EB071E5C0DB6}" destId="{6D7ED019-6E6E-404A-A7C2-51CCC754E0BE}" srcOrd="2" destOrd="0" parTransId="{3B7EB2F2-F43D-49F9-B724-1C5C5B510253}" sibTransId="{96D0803D-9B4B-43C9-A0FA-DC510623477B}"/>
    <dgm:cxn modelId="{046050E3-FB55-4F7F-806E-910C10396B31}" srcId="{37225B65-CFDC-423E-B303-EB071E5C0DB6}" destId="{6747797B-B899-44E5-AA3F-D3B8F1B1047F}" srcOrd="0" destOrd="0" parTransId="{7FF41D5F-8B72-41E1-8EF4-525AA0B40B47}" sibTransId="{0140ED0C-8D81-4754-9555-E2086B216733}"/>
    <dgm:cxn modelId="{14B94DEB-E338-4039-962D-604FDA2E8E7C}" srcId="{8C2D7B77-45D1-43D8-BBC3-A807DD536278}" destId="{ED45B463-6755-46F3-A13E-1DE0376C2153}" srcOrd="2" destOrd="0" parTransId="{5FBC1F8D-C27B-4906-A556-27D5ED06F853}" sibTransId="{14CDA06D-2B95-4C15-9519-CC8407C6AE55}"/>
    <dgm:cxn modelId="{4784A0EF-F85A-4FDA-970A-2754037286F8}" srcId="{8C2D7B77-45D1-43D8-BBC3-A807DD536278}" destId="{9D877A12-259A-4C0F-97F6-D818F4CB978B}" srcOrd="0" destOrd="0" parTransId="{621661AE-6D8B-4157-9FD3-B356BF3CA2CA}" sibTransId="{1AFBB74E-274A-4BB3-9902-B779AE29210A}"/>
    <dgm:cxn modelId="{9481CEF3-DA25-402D-A85B-C51B9CFF927A}" srcId="{84AF97C2-58C6-417F-98D0-02F8F9986A1D}" destId="{A743DBA1-2F65-4049-97C1-7ECA5238837C}" srcOrd="2" destOrd="0" parTransId="{07FDF71B-EC48-459C-8FB5-8394356553F3}" sibTransId="{D82AEE17-C8C5-459F-AE4F-01477B1C89DE}"/>
    <dgm:cxn modelId="{2F2698F5-7505-4678-8A56-3BF7613C6A20}" srcId="{8C2D7B77-45D1-43D8-BBC3-A807DD536278}" destId="{72E5E352-CB8E-4B2D-BE9C-560EECB9C3CE}" srcOrd="1" destOrd="0" parTransId="{4BC63948-24BD-4448-98CA-838DF82D3ED5}" sibTransId="{59EF8D98-7F2B-4D50-A8EA-04B69B2FAC27}"/>
    <dgm:cxn modelId="{51C84880-F951-4F2A-AF5E-FDFD88235AA8}" type="presParOf" srcId="{8C9D435A-6906-4FE5-80FF-436A97972A64}" destId="{2E1443A1-8847-432A-83C4-2C46945FBC26}" srcOrd="0" destOrd="0" presId="urn:microsoft.com/office/officeart/2005/8/layout/process3"/>
    <dgm:cxn modelId="{18A53404-880F-4993-99FD-3BA10E47C9BB}" type="presParOf" srcId="{2E1443A1-8847-432A-83C4-2C46945FBC26}" destId="{06A43DF9-A45E-4542-8938-1AFF65968571}" srcOrd="0" destOrd="0" presId="urn:microsoft.com/office/officeart/2005/8/layout/process3"/>
    <dgm:cxn modelId="{54ABB153-0A49-477D-A88A-E77D42D834E0}" type="presParOf" srcId="{2E1443A1-8847-432A-83C4-2C46945FBC26}" destId="{9D94E0DF-D093-451A-BA94-245F4E25FF6E}" srcOrd="1" destOrd="0" presId="urn:microsoft.com/office/officeart/2005/8/layout/process3"/>
    <dgm:cxn modelId="{E5516E0B-6710-49EE-8CB5-757FE64AD80B}" type="presParOf" srcId="{2E1443A1-8847-432A-83C4-2C46945FBC26}" destId="{917C1247-217C-4F7D-A008-0C6DBB91F0AA}" srcOrd="2" destOrd="0" presId="urn:microsoft.com/office/officeart/2005/8/layout/process3"/>
    <dgm:cxn modelId="{87D14D82-4085-493E-90A7-0ED460DD1217}" type="presParOf" srcId="{8C9D435A-6906-4FE5-80FF-436A97972A64}" destId="{51ABA5FE-6BEC-424A-98E2-BBAFFB97CB9A}" srcOrd="1" destOrd="0" presId="urn:microsoft.com/office/officeart/2005/8/layout/process3"/>
    <dgm:cxn modelId="{889F0CEF-16F1-4DD9-A3D4-172E7ABD6D55}" type="presParOf" srcId="{51ABA5FE-6BEC-424A-98E2-BBAFFB97CB9A}" destId="{0DCF4D41-817E-412D-AEA1-CC5CD6F080DF}" srcOrd="0" destOrd="0" presId="urn:microsoft.com/office/officeart/2005/8/layout/process3"/>
    <dgm:cxn modelId="{DAA2F94A-2883-4275-84C9-8BC8E6B874AF}" type="presParOf" srcId="{8C9D435A-6906-4FE5-80FF-436A97972A64}" destId="{DF24F8F6-FE6F-4EBE-9878-BA60388BAC98}" srcOrd="2" destOrd="0" presId="urn:microsoft.com/office/officeart/2005/8/layout/process3"/>
    <dgm:cxn modelId="{DBE2434F-7E41-4C19-BDDD-7732B135F6C2}" type="presParOf" srcId="{DF24F8F6-FE6F-4EBE-9878-BA60388BAC98}" destId="{B5D3592F-7899-4513-B6EE-2D08F22B2D9C}" srcOrd="0" destOrd="0" presId="urn:microsoft.com/office/officeart/2005/8/layout/process3"/>
    <dgm:cxn modelId="{C27E52C2-2EAE-454E-BD29-2688822BA281}" type="presParOf" srcId="{DF24F8F6-FE6F-4EBE-9878-BA60388BAC98}" destId="{74989205-42F1-4AC8-B701-B632D7FEE30C}" srcOrd="1" destOrd="0" presId="urn:microsoft.com/office/officeart/2005/8/layout/process3"/>
    <dgm:cxn modelId="{7298DD1E-E456-4F6C-B575-365298E926F7}" type="presParOf" srcId="{DF24F8F6-FE6F-4EBE-9878-BA60388BAC98}" destId="{F6B44B51-1360-45F1-888A-55A538C8C211}" srcOrd="2" destOrd="0" presId="urn:microsoft.com/office/officeart/2005/8/layout/process3"/>
    <dgm:cxn modelId="{F2EA7196-53E5-4C39-90DF-EAEAD9D3A9B2}" type="presParOf" srcId="{8C9D435A-6906-4FE5-80FF-436A97972A64}" destId="{00181115-EF53-4153-AFF5-C35CEB2851D7}" srcOrd="3" destOrd="0" presId="urn:microsoft.com/office/officeart/2005/8/layout/process3"/>
    <dgm:cxn modelId="{5303FFE6-FF7C-4C25-A5BA-63B1EAF3FF97}" type="presParOf" srcId="{00181115-EF53-4153-AFF5-C35CEB2851D7}" destId="{311B592D-FB73-491B-ADC8-6E2543AB2FC3}" srcOrd="0" destOrd="0" presId="urn:microsoft.com/office/officeart/2005/8/layout/process3"/>
    <dgm:cxn modelId="{4646615E-543F-4548-B790-6BC36920A77B}" type="presParOf" srcId="{8C9D435A-6906-4FE5-80FF-436A97972A64}" destId="{EEC457B4-8AA4-4A0C-A1CB-16FD2A5B667F}" srcOrd="4" destOrd="0" presId="urn:microsoft.com/office/officeart/2005/8/layout/process3"/>
    <dgm:cxn modelId="{EE26FDE2-A7FA-4354-BCB0-D729C94F3A81}" type="presParOf" srcId="{EEC457B4-8AA4-4A0C-A1CB-16FD2A5B667F}" destId="{9832D3FC-FCDE-4DA9-8E76-7B2714338FE1}" srcOrd="0" destOrd="0" presId="urn:microsoft.com/office/officeart/2005/8/layout/process3"/>
    <dgm:cxn modelId="{EC79EFFA-EA1D-42D9-97C8-4AA5A9180AD4}" type="presParOf" srcId="{EEC457B4-8AA4-4A0C-A1CB-16FD2A5B667F}" destId="{ACB06B7E-B6E7-4D8E-BAFB-837050603E17}" srcOrd="1" destOrd="0" presId="urn:microsoft.com/office/officeart/2005/8/layout/process3"/>
    <dgm:cxn modelId="{39AAA191-1E86-45F3-8FFE-A340BD36EA15}" type="presParOf" srcId="{EEC457B4-8AA4-4A0C-A1CB-16FD2A5B667F}" destId="{74F4E7DC-FF92-4C0E-A9C4-6EC6F3B4479C}" srcOrd="2" destOrd="0" presId="urn:microsoft.com/office/officeart/2005/8/layout/process3"/>
    <dgm:cxn modelId="{C1DF383D-0624-4D5C-89F2-A117278B9998}" type="presParOf" srcId="{8C9D435A-6906-4FE5-80FF-436A97972A64}" destId="{F9273A91-9601-40FB-A9D2-4F082CD5BD3F}" srcOrd="5" destOrd="0" presId="urn:microsoft.com/office/officeart/2005/8/layout/process3"/>
    <dgm:cxn modelId="{D8F10279-3902-4F1C-BF2D-A74E1D67334B}" type="presParOf" srcId="{F9273A91-9601-40FB-A9D2-4F082CD5BD3F}" destId="{3E64A7D6-9D26-448F-AA22-D0C5BE1A2CEB}" srcOrd="0" destOrd="0" presId="urn:microsoft.com/office/officeart/2005/8/layout/process3"/>
    <dgm:cxn modelId="{E3979045-1042-4D4E-BEB5-14CFC81074D1}" type="presParOf" srcId="{8C9D435A-6906-4FE5-80FF-436A97972A64}" destId="{04DF62D2-E0D6-4640-AE15-641B54766C48}" srcOrd="6" destOrd="0" presId="urn:microsoft.com/office/officeart/2005/8/layout/process3"/>
    <dgm:cxn modelId="{39FF6FE8-53F8-4408-B198-8E862A268615}" type="presParOf" srcId="{04DF62D2-E0D6-4640-AE15-641B54766C48}" destId="{2CD7734F-57C3-4F5C-9B14-25FB2F8929C3}" srcOrd="0" destOrd="0" presId="urn:microsoft.com/office/officeart/2005/8/layout/process3"/>
    <dgm:cxn modelId="{6339275F-27ED-486F-960D-F628D47FF8A5}" type="presParOf" srcId="{04DF62D2-E0D6-4640-AE15-641B54766C48}" destId="{D3123666-A23F-46C6-8F81-010D263DA991}" srcOrd="1" destOrd="0" presId="urn:microsoft.com/office/officeart/2005/8/layout/process3"/>
    <dgm:cxn modelId="{6899A0C0-62AE-45F8-BA9A-6475A8443948}" type="presParOf" srcId="{04DF62D2-E0D6-4640-AE15-641B54766C48}" destId="{BEE2EF34-85E5-478B-BBE5-3640567F4C03}" srcOrd="2" destOrd="0" presId="urn:microsoft.com/office/officeart/2005/8/layout/process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D94E0DF-D093-451A-BA94-245F4E25FF6E}">
      <dsp:nvSpPr>
        <dsp:cNvPr id="0" name=""/>
        <dsp:cNvSpPr/>
      </dsp:nvSpPr>
      <dsp:spPr>
        <a:xfrm>
          <a:off x="1205" y="0"/>
          <a:ext cx="1576490" cy="2764800"/>
        </a:xfrm>
        <a:prstGeom prst="roundRect">
          <a:avLst>
            <a:gd name="adj" fmla="val 10000"/>
          </a:avLst>
        </a:prstGeom>
        <a:solidFill>
          <a:schemeClr val="tx1"/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68580" numCol="1" spcCol="1270" anchor="t" anchorCtr="0">
          <a:noAutofit/>
        </a:bodyPr>
        <a:lstStyle/>
        <a:p>
          <a:pPr marL="0" lvl="0" indent="0" algn="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tage 1: Information Gathering</a:t>
          </a:r>
        </a:p>
      </dsp:txBody>
      <dsp:txXfrm>
        <a:off x="1205" y="0"/>
        <a:ext cx="1576490" cy="761681"/>
      </dsp:txXfrm>
    </dsp:sp>
    <dsp:sp modelId="{917C1247-217C-4F7D-A008-0C6DBB91F0AA}">
      <dsp:nvSpPr>
        <dsp:cNvPr id="0" name=""/>
        <dsp:cNvSpPr/>
      </dsp:nvSpPr>
      <dsp:spPr>
        <a:xfrm>
          <a:off x="42811" y="910020"/>
          <a:ext cx="1904204" cy="31326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99568" rIns="99568" bIns="99568" numCol="1" spcCol="1270" anchor="t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Literature Review of dietary interventions in older adults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Discussion Group with clinic staff and providers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In-Depth Interviews with NMIBC survivors</a:t>
          </a:r>
        </a:p>
      </dsp:txBody>
      <dsp:txXfrm>
        <a:off x="98583" y="965792"/>
        <a:ext cx="1792660" cy="3021121"/>
      </dsp:txXfrm>
    </dsp:sp>
    <dsp:sp modelId="{51ABA5FE-6BEC-424A-98E2-BBAFFB97CB9A}">
      <dsp:nvSpPr>
        <dsp:cNvPr id="0" name=""/>
        <dsp:cNvSpPr/>
      </dsp:nvSpPr>
      <dsp:spPr>
        <a:xfrm>
          <a:off x="1589591" y="182722"/>
          <a:ext cx="1921853" cy="474091"/>
        </a:xfrm>
        <a:prstGeom prst="rightArrow">
          <a:avLst>
            <a:gd name="adj1" fmla="val 60000"/>
            <a:gd name="adj2" fmla="val 50000"/>
          </a:avLst>
        </a:prstGeom>
        <a:solidFill>
          <a:schemeClr val="tx1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000" kern="1200"/>
        </a:p>
      </dsp:txBody>
      <dsp:txXfrm>
        <a:off x="1589591" y="277540"/>
        <a:ext cx="1779626" cy="284455"/>
      </dsp:txXfrm>
    </dsp:sp>
    <dsp:sp modelId="{74989205-42F1-4AC8-B701-B632D7FEE30C}">
      <dsp:nvSpPr>
        <dsp:cNvPr id="0" name=""/>
        <dsp:cNvSpPr/>
      </dsp:nvSpPr>
      <dsp:spPr>
        <a:xfrm>
          <a:off x="3771978" y="0"/>
          <a:ext cx="1926464" cy="2764800"/>
        </a:xfrm>
        <a:prstGeom prst="roundRect">
          <a:avLst>
            <a:gd name="adj" fmla="val 10000"/>
          </a:avLst>
        </a:prstGeom>
        <a:solidFill>
          <a:schemeClr val="tx1">
            <a:lumMod val="75000"/>
            <a:lumOff val="2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68580" numCol="1" spcCol="1270" anchor="t" anchorCtr="0">
          <a:noAutofit/>
        </a:bodyPr>
        <a:lstStyle/>
        <a:p>
          <a:pPr marL="0" lvl="0" indent="0" algn="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tage 2: Preliminary Adaption Design</a:t>
          </a:r>
        </a:p>
      </dsp:txBody>
      <dsp:txXfrm>
        <a:off x="3771978" y="0"/>
        <a:ext cx="1926464" cy="761681"/>
      </dsp:txXfrm>
    </dsp:sp>
    <dsp:sp modelId="{F6B44B51-1360-45F1-888A-55A538C8C211}">
      <dsp:nvSpPr>
        <dsp:cNvPr id="0" name=""/>
        <dsp:cNvSpPr/>
      </dsp:nvSpPr>
      <dsp:spPr>
        <a:xfrm>
          <a:off x="3936433" y="905596"/>
          <a:ext cx="1904204" cy="3169234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99568" rIns="99568" bIns="99568" numCol="1" spcCol="1270" anchor="t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Incorporation of evidence-based behavioral techniques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Grounded intervention in Social Cognitive Theory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Integrated intervention strategies from PEN-3 Model analyses and qualitative results (Table 2)</a:t>
          </a:r>
        </a:p>
      </dsp:txBody>
      <dsp:txXfrm>
        <a:off x="3992205" y="961368"/>
        <a:ext cx="1792660" cy="3057690"/>
      </dsp:txXfrm>
    </dsp:sp>
    <dsp:sp modelId="{00181115-EF53-4153-AFF5-C35CEB2851D7}">
      <dsp:nvSpPr>
        <dsp:cNvPr id="0" name=""/>
        <dsp:cNvSpPr/>
      </dsp:nvSpPr>
      <dsp:spPr>
        <a:xfrm>
          <a:off x="5712354" y="187122"/>
          <a:ext cx="320007" cy="474091"/>
        </a:xfrm>
        <a:prstGeom prst="rightArrow">
          <a:avLst>
            <a:gd name="adj1" fmla="val 60000"/>
            <a:gd name="adj2" fmla="val 50000"/>
          </a:avLst>
        </a:prstGeom>
        <a:solidFill>
          <a:schemeClr val="tx1">
            <a:lumMod val="75000"/>
            <a:lumOff val="2500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000" kern="1200"/>
        </a:p>
      </dsp:txBody>
      <dsp:txXfrm>
        <a:off x="5712354" y="281940"/>
        <a:ext cx="224005" cy="284455"/>
      </dsp:txXfrm>
    </dsp:sp>
    <dsp:sp modelId="{ACB06B7E-B6E7-4D8E-BAFB-837050603E17}">
      <dsp:nvSpPr>
        <dsp:cNvPr id="0" name=""/>
        <dsp:cNvSpPr/>
      </dsp:nvSpPr>
      <dsp:spPr>
        <a:xfrm>
          <a:off x="6064870" y="0"/>
          <a:ext cx="1778260" cy="2764800"/>
        </a:xfrm>
        <a:prstGeom prst="roundRect">
          <a:avLst>
            <a:gd name="adj" fmla="val 10000"/>
          </a:avLst>
        </a:prstGeom>
        <a:solidFill>
          <a:schemeClr val="tx1">
            <a:lumMod val="50000"/>
            <a:lumOff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68580" numCol="1" spcCol="1270" anchor="t" anchorCtr="0">
          <a:noAutofit/>
        </a:bodyPr>
        <a:lstStyle/>
        <a:p>
          <a:pPr marL="0" lvl="0" indent="0" algn="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tage 3: Preliminary Adaptation Tests	</a:t>
          </a:r>
        </a:p>
      </dsp:txBody>
      <dsp:txXfrm>
        <a:off x="6064870" y="0"/>
        <a:ext cx="1778260" cy="761681"/>
      </dsp:txXfrm>
    </dsp:sp>
    <dsp:sp modelId="{74F4E7DC-FF92-4C0E-A9C4-6EC6F3B4479C}">
      <dsp:nvSpPr>
        <dsp:cNvPr id="0" name=""/>
        <dsp:cNvSpPr/>
      </dsp:nvSpPr>
      <dsp:spPr>
        <a:xfrm>
          <a:off x="6184205" y="1234552"/>
          <a:ext cx="1904204" cy="179324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tx1">
              <a:lumMod val="50000"/>
              <a:lumOff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99568" rIns="99568" bIns="99568" numCol="1" spcCol="1270" anchor="t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Iterative review of intervention materials and pilot testing phone-based intervention components</a:t>
          </a:r>
        </a:p>
      </dsp:txBody>
      <dsp:txXfrm>
        <a:off x="6236727" y="1287074"/>
        <a:ext cx="1799160" cy="1688205"/>
      </dsp:txXfrm>
    </dsp:sp>
    <dsp:sp modelId="{F9273A91-9601-40FB-A9D2-4F082CD5BD3F}">
      <dsp:nvSpPr>
        <dsp:cNvPr id="0" name=""/>
        <dsp:cNvSpPr/>
      </dsp:nvSpPr>
      <dsp:spPr>
        <a:xfrm>
          <a:off x="7873355" y="198917"/>
          <a:ext cx="492317" cy="474091"/>
        </a:xfrm>
        <a:prstGeom prst="rightArrow">
          <a:avLst>
            <a:gd name="adj1" fmla="val 60000"/>
            <a:gd name="adj2" fmla="val 50000"/>
          </a:avLst>
        </a:prstGeom>
        <a:solidFill>
          <a:schemeClr val="tx1">
            <a:lumMod val="50000"/>
            <a:lumOff val="5000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000" kern="1200"/>
        </a:p>
      </dsp:txBody>
      <dsp:txXfrm>
        <a:off x="7873355" y="293735"/>
        <a:ext cx="350090" cy="284455"/>
      </dsp:txXfrm>
    </dsp:sp>
    <dsp:sp modelId="{D3123666-A23F-46C6-8F81-010D263DA991}">
      <dsp:nvSpPr>
        <dsp:cNvPr id="0" name=""/>
        <dsp:cNvSpPr/>
      </dsp:nvSpPr>
      <dsp:spPr>
        <a:xfrm>
          <a:off x="8417163" y="0"/>
          <a:ext cx="1604463" cy="2764800"/>
        </a:xfrm>
        <a:prstGeom prst="roundRect">
          <a:avLst>
            <a:gd name="adj" fmla="val 10000"/>
          </a:avLst>
        </a:prstGeom>
        <a:solidFill>
          <a:schemeClr val="bg2">
            <a:lumMod val="7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68580" numCol="1" spcCol="1270" anchor="t" anchorCtr="0">
          <a:noAutofit/>
        </a:bodyPr>
        <a:lstStyle/>
        <a:p>
          <a:pPr marL="0" lvl="0" indent="0" algn="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tage 4: Adaptation Refinement</a:t>
          </a:r>
        </a:p>
      </dsp:txBody>
      <dsp:txXfrm>
        <a:off x="8417163" y="0"/>
        <a:ext cx="1604463" cy="761681"/>
      </dsp:txXfrm>
    </dsp:sp>
    <dsp:sp modelId="{BEE2EF34-85E5-478B-BBE5-3640567F4C03}">
      <dsp:nvSpPr>
        <dsp:cNvPr id="0" name=""/>
        <dsp:cNvSpPr/>
      </dsp:nvSpPr>
      <dsp:spPr>
        <a:xfrm>
          <a:off x="8522017" y="1288834"/>
          <a:ext cx="1904204" cy="1938714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99568" rIns="99568" bIns="99568" numCol="1" spcCol="1270" anchor="t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400" kern="1200" dirty="0"/>
            <a:t>Final review of intervention products before intervention delivery, resulting in the POW-R Health Intervention   </a:t>
          </a:r>
        </a:p>
      </dsp:txBody>
      <dsp:txXfrm>
        <a:off x="8577789" y="1344606"/>
        <a:ext cx="1792660" cy="182717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3">
  <dgm:title val=""/>
  <dgm:desc val=""/>
  <dgm:catLst>
    <dgm:cat type="process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3" destOrd="0"/>
        <dgm:cxn modelId="12" srcId="1" destId="11" srcOrd="0" destOrd="0"/>
        <dgm:cxn modelId="23" srcId="2" destId="21" srcOrd="0" destOrd="0"/>
        <dgm:cxn modelId="34" srcId="3" destId="31" srcOrd="0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  <dgm:pt modelId="4">
          <dgm:prSet phldr="1"/>
        </dgm:pt>
        <dgm:pt modelId="41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choose name="Name0">
      <dgm:if name="Name1" func="var" arg="dir" op="equ" val="norm">
        <dgm:alg type="lin"/>
      </dgm:if>
      <dgm:else name="Name2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osite" refType="w"/>
      <dgm:constr type="w" for="ch" ptType="sibTrans" refType="w" refFor="ch" refForName="composite" fact="0.3333"/>
      <dgm:constr type="w" for="des" forName="parTx"/>
      <dgm:constr type="h" for="des" forName="parTx" op="equ"/>
      <dgm:constr type="h" for="des" forName="parSh" op="equ"/>
      <dgm:constr type="w" for="des" forName="desTx"/>
      <dgm:constr type="h" for="des" forName="desTx" op="equ"/>
      <dgm:constr type="w" for="des" forName="parSh"/>
      <dgm:constr type="primFontSz" for="des" forName="parTx" val="65"/>
      <dgm:constr type="secFontSz" for="des" forName="desTx" refType="primFontSz" refFor="des" refForName="parTx" op="equ"/>
      <dgm:constr type="primFontSz" for="des" forName="connTx" refType="primFontSz" refFor="des" refForName="parTx" fact="0.8"/>
      <dgm:constr type="primFontSz" for="des" forName="connTx" refType="primFontSz" refFor="des" refForName="parTx" op="lte" fact="0.8"/>
      <dgm:constr type="h" for="des" forName="parTx" refType="primFontSz" refFor="des" refForName="parTx" fact="0.8"/>
      <dgm:constr type="h" for="des" forName="parSh" refType="primFontSz" refFor="des" refForName="parTx" fact="1.2"/>
      <dgm:constr type="h" for="des" forName="desTx" refType="primFontSz" refFor="des" refForName="parTx" fact="1.6"/>
      <dgm:constr type="h" for="des" forName="parSh" refType="h" refFor="des" refForName="parTx" op="lte" fact="1.5"/>
      <dgm:constr type="h" for="des" forName="parSh" refType="h" refFor="des" refForName="parTx" op="gte" fact="1.5"/>
    </dgm:constrLst>
    <dgm:ruleLst>
      <dgm:rule type="w" for="ch" forName="composite" val="0" fact="NaN" max="NaN"/>
      <dgm:rule type="primFontSz" for="des" forName="parTx" val="5" fact="NaN" max="NaN"/>
    </dgm:ruleLst>
    <dgm:forEach name="Name3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4">
          <dgm:if name="Name5" func="var" arg="dir" op="equ" val="norm">
            <dgm:constrLst>
              <dgm:constr type="h" refType="w" fact="1000"/>
              <dgm:constr type="l" for="ch" forName="parTx"/>
              <dgm:constr type="w" for="ch" forName="parTx" refType="w" fact="0.83"/>
              <dgm:constr type="t" for="ch" forName="parTx"/>
              <dgm:constr type="l" for="ch" forName="parSh"/>
              <dgm:constr type="w" for="ch" forName="parSh" refType="w" refFor="ch" refForName="parTx"/>
              <dgm:constr type="t" for="ch" forName="parSh"/>
              <dgm:constr type="l" for="ch" forName="desTx" refType="w" fact="0.17"/>
              <dgm:constr type="w" for="ch" forName="desTx" refType="w" refFor="ch" refForName="parTx"/>
              <dgm:constr type="t" for="ch" forName="desTx" refType="h" refFor="ch" refForName="parTx"/>
            </dgm:constrLst>
          </dgm:if>
          <dgm:else name="Name6">
            <dgm:constrLst>
              <dgm:constr type="h" refType="w" fact="1000"/>
              <dgm:constr type="l" for="ch" forName="parTx" refType="w" fact="0.17"/>
              <dgm:constr type="w" for="ch" forName="parTx" refType="w" fact="0.83"/>
              <dgm:constr type="t" for="ch" forName="parTx"/>
              <dgm:constr type="l" for="ch" forName="parSh" refType="w" fact="0.15"/>
              <dgm:constr type="w" for="ch" forName="parSh" refType="w" refFor="ch" refForName="parTx"/>
              <dgm:constr type="t" for="ch" forName="parSh"/>
              <dgm:constr type="l" for="ch" forName="desTx"/>
              <dgm:constr type="w" for="ch" forName="desTx" refType="w" refFor="ch" refForName="parTx"/>
              <dgm:constr type="t" for="ch" forName="desTx" refType="h" refFor="ch" refForName="parTx"/>
            </dgm:constrLst>
          </dgm:else>
        </dgm:choose>
        <dgm:ruleLst>
          <dgm:rule type="h" val="INF" fact="NaN" max="NaN"/>
        </dgm:ruleLst>
        <dgm:layoutNode name="parTx">
          <dgm:varLst>
            <dgm:chMax val="0"/>
            <dgm:chPref val="0"/>
            <dgm:bulletEnabled val="1"/>
          </dgm:varLst>
          <dgm:alg type="tx">
            <dgm:param type="parTxLTRAlign" val="l"/>
            <dgm:param type="parTxRTLAlign" val="r"/>
            <dgm:param type="txAnchorVert" val="t"/>
          </dgm:alg>
          <dgm:shape xmlns:r="http://schemas.openxmlformats.org/officeDocument/2006/relationships" type="rect" r:blip="" zOrderOff="1" hideGeom="1">
            <dgm:adjLst>
              <dgm:adj idx="1" val="0.1"/>
            </dgm:adjLst>
          </dgm:shape>
          <dgm:presOf axis="self" ptType="node"/>
          <dgm:constrLst>
            <dgm:constr type="h" refType="w" op="lte" fact="0.4"/>
            <dgm:constr type="bMarg" refType="primFontSz" fact="0.3"/>
            <dgm:constr type="h"/>
          </dgm:constrLst>
          <dgm:ruleLst>
            <dgm:rule type="h" val="INF" fact="NaN" max="NaN"/>
          </dgm:ruleLst>
        </dgm:layoutNode>
        <dgm:layoutNode name="parSh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 axis="self" ptType="node"/>
          <dgm:constrLst>
            <dgm:constr type="h"/>
          </dgm:constrLst>
          <dgm:ruleLst/>
        </dgm:layoutNode>
        <dgm:layoutNode name="desTx" styleLbl="fgAcc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oundRect" r:blip="">
            <dgm:adjLst>
              <dgm:adj idx="1" val="0.1"/>
            </dgm:adjLst>
          </dgm:shape>
          <dgm:presOf axis="des" ptType="node"/>
          <dgm:constrLst>
            <dgm:constr type="secFontSz" val="65"/>
            <dgm:constr type="primFontSz" refType="secFontSz"/>
            <dgm:constr type="h"/>
          </dgm:constrLst>
          <dgm:ruleLst>
            <dgm:rule type="h" val="INF" fact="NaN" max="NaN"/>
          </dgm:ruleLst>
        </dgm:layoutNode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  <dgm:param type="srcNode" val="parTx"/>
            <dgm:param type="dstNode" val="parTx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Tx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AA8CB-761C-41DE-8073-531A6BFF7C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C1FAD3-12B7-407A-8616-3195EB7C32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951F51-E0E6-4B56-B30F-BC5052A82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BAEFD1-5FAF-47E1-AD46-6F416BED4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E67ADC-8BD6-42B6-9D36-D7358942C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440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FEAA0-04DF-496F-A65B-678A3C8846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B9B106-ED5A-409A-B368-503A886D50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FD587F-AC3E-491C-A131-5E94AB1F0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EF0A67-E9A5-4F73-AFC4-85864E56D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F55F0D-2EE8-408D-B800-1E1517EDD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918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1B3F17-04EC-4046-907F-FD5AB4BBD3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697C5C-C563-4E9E-A8A1-8D7FA33AF8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411D8A-A3DF-41F3-B268-3B0B50445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D09F87-F53C-4B58-9CF0-F1384D620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B862C-4272-44C3-B766-42037D70D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009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92912-2575-49F7-97B9-8016B5DC1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C05149-88F7-411E-81E9-A98EBF1349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D4F58-854D-41BB-942D-1DB6ACC0B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DCF71-DAA2-417B-BC29-EC700CDF1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86586-319E-4A33-8EF7-4BFC72EAF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4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093D5D-BEC1-49A9-8D50-AA105C8AE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A9E29E-A7A6-4E4B-9362-ADDDB3C73E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ED0E0-B2E5-422F-A6B0-506EA5E97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A46A00-00D6-4CDA-B5C2-864CAA5B5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EB78E3-6657-42DD-BDAF-7E8A74008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701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8C2CE-3183-43C1-854C-2552E7A32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4AF51E-C9DB-4617-9BBC-D71C0CD360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2CE49B-F038-4B84-8DA5-7A14747EDE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18F754-7AEE-4A3D-9B82-6D07118D3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B699D7-B8D8-4830-BB94-D64CB3AE2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4751A3-2CF8-44F2-BCFD-235D33C69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945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7C7E69-EB1E-42A2-ABEE-9CA4B77C6D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1E04B-EA9E-417F-9A8B-6AFDE313FC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8B928D-BE25-4F41-8B96-2BA853DEAA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F601C0-7A2B-4130-BBAA-2E239E0B33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A509A1-748D-4DE8-8497-CB77106AE5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B4E160-7E5E-4798-A5DC-911823AFF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23927E-DB9D-4C31-8BB0-54B668094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E54972-B86E-4104-B10F-BF2773C58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163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0DBCB6-A4E2-4773-B450-EA34029ED1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C64D30-E60E-4013-8812-ABF2E0A7A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4CD3D4-3582-4C1E-8898-C908FC277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1AB11A-A561-41E3-986F-77707F422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537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9B5690-F4D8-4665-8D55-C43127AE4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9D5C98-69F8-4283-BE1C-364BFA396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E95B8C-7621-4B1B-8077-A4AF96917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843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A2B4F-C5E2-4815-BF9C-336671066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46F008-BD06-4786-8337-B5731D3D7D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475BA3-152A-42DA-B8C6-CF5550D7D9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82D672-0C7C-4F1A-B651-EA9216D50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680156-EBC7-4326-ADFF-1ADC4B688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A2AFD6-5025-41A7-B1F9-CC217AD0C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12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10B194-02F3-44DC-A4A0-B52273A49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9BD5B2-0BE2-4E45-BBEE-EE01E571B5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06FA5B-8F3E-4661-BB7B-5E7454A2B8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DB7C52-9AF8-43A8-A3DB-BA2099313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FB90F-2795-4DF3-8FE6-04ECB61B6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20EAE6-4905-4EF4-BA85-AD24ED68E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600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BDF4C3-ABD8-4405-8D1A-5D0B90FAB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C6FA26-346A-4878-B7E7-75699CCC2E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2756FF-4EA6-476A-B31D-D184EF4132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77FB9-9950-4746-ABE0-159DDE134D60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44C73-BB70-49D4-BCB4-8A35C27C1E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29DE2B-A728-4733-B55A-DAF30B8D0F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0BD34-3945-45D1-82D1-62428294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435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955A2079-FA98-4876-80F0-72364A7D2E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BFA4863D-1E47-482D-92F0-7D1180BB363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93772207"/>
              </p:ext>
            </p:extLst>
          </p:nvPr>
        </p:nvGraphicFramePr>
        <p:xfrm>
          <a:off x="838199" y="1828800"/>
          <a:ext cx="11107723" cy="435254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10" name="Group 9">
            <a:extLst>
              <a:ext uri="{FF2B5EF4-FFF2-40B4-BE49-F238E27FC236}">
                <a16:creationId xmlns:a16="http://schemas.microsoft.com/office/drawing/2014/main" id="{9A99D4CB-15D8-47D7-8E69-2631AC8BCC2B}"/>
              </a:ext>
            </a:extLst>
          </p:cNvPr>
          <p:cNvGrpSpPr/>
          <p:nvPr/>
        </p:nvGrpSpPr>
        <p:grpSpPr>
          <a:xfrm>
            <a:off x="2836778" y="2734811"/>
            <a:ext cx="1882706" cy="3129094"/>
            <a:chOff x="4212759" y="735315"/>
            <a:chExt cx="1843431" cy="3549600"/>
          </a:xfrm>
          <a:solidFill>
            <a:schemeClr val="bg1">
              <a:lumMod val="75000"/>
            </a:schemeClr>
          </a:solidFill>
        </p:grpSpPr>
        <p:sp>
          <p:nvSpPr>
            <p:cNvPr id="11" name="Rectangle: Rounded Corners 10">
              <a:extLst>
                <a:ext uri="{FF2B5EF4-FFF2-40B4-BE49-F238E27FC236}">
                  <a16:creationId xmlns:a16="http://schemas.microsoft.com/office/drawing/2014/main" id="{48061523-E8E3-4713-9020-DEDA4014A192}"/>
                </a:ext>
              </a:extLst>
            </p:cNvPr>
            <p:cNvSpPr/>
            <p:nvPr/>
          </p:nvSpPr>
          <p:spPr>
            <a:xfrm>
              <a:off x="4212759" y="735315"/>
              <a:ext cx="1843431" cy="3549600"/>
            </a:xfrm>
            <a:prstGeom prst="roundRect">
              <a:avLst>
                <a:gd name="adj" fmla="val 10000"/>
              </a:avLst>
            </a:prstGeom>
            <a:grpFill/>
            <a:ln>
              <a:noFill/>
            </a:ln>
          </p:spPr>
          <p:style>
            <a:lnRef idx="2">
              <a:schemeClr val="accent3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 dirty="0"/>
            </a:p>
          </p:txBody>
        </p:sp>
        <p:sp>
          <p:nvSpPr>
            <p:cNvPr id="12" name="Rectangle: Rounded Corners 4">
              <a:extLst>
                <a:ext uri="{FF2B5EF4-FFF2-40B4-BE49-F238E27FC236}">
                  <a16:creationId xmlns:a16="http://schemas.microsoft.com/office/drawing/2014/main" id="{A0265B65-3D76-4965-92B0-248AC85BFBDC}"/>
                </a:ext>
              </a:extLst>
            </p:cNvPr>
            <p:cNvSpPr txBox="1"/>
            <p:nvPr/>
          </p:nvSpPr>
          <p:spPr>
            <a:xfrm>
              <a:off x="4266751" y="789307"/>
              <a:ext cx="1735447" cy="3441963"/>
            </a:xfrm>
            <a:prstGeom prst="rect">
              <a:avLst/>
            </a:prstGeom>
            <a:grp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20904" tIns="120904" rIns="120904" bIns="120904" numCol="1" spcCol="1270" anchor="t" anchorCtr="0">
              <a:noAutofit/>
            </a:bodyPr>
            <a:lstStyle/>
            <a:p>
              <a:pPr marL="171450" lvl="1" indent="-171450" algn="l" defTabSz="7556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400" kern="1200" dirty="0"/>
                <a:t>Identification of evidence-based behavioral techniques</a:t>
              </a:r>
            </a:p>
            <a:p>
              <a:pPr marL="171450" lvl="1" indent="-171450" algn="l" defTabSz="7556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400" kern="1200" dirty="0"/>
                <a:t>Identificatio</a:t>
              </a:r>
              <a:r>
                <a:rPr lang="en-US" sz="1400" dirty="0"/>
                <a:t>n of b</a:t>
              </a:r>
              <a:r>
                <a:rPr lang="en-US" sz="1400" kern="1200" dirty="0"/>
                <a:t>ehavioral </a:t>
              </a:r>
              <a:r>
                <a:rPr lang="en-US" sz="1400" dirty="0"/>
                <a:t>t</a:t>
              </a:r>
              <a:r>
                <a:rPr lang="en-US" sz="1400" kern="1200" dirty="0"/>
                <a:t>heories used in prior successful dietary interventions</a:t>
              </a:r>
            </a:p>
            <a:p>
              <a:pPr marL="171450" lvl="1" indent="-171450" algn="l" defTabSz="7556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400" kern="1200" dirty="0"/>
                <a:t>Application of the PEN-3 Model and qualitative methods (Table 1)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863F823-4BB7-4A52-A01E-B0D6B4FEDBAD}"/>
              </a:ext>
            </a:extLst>
          </p:cNvPr>
          <p:cNvSpPr txBox="1"/>
          <p:nvPr/>
        </p:nvSpPr>
        <p:spPr>
          <a:xfrm>
            <a:off x="2836778" y="2058155"/>
            <a:ext cx="1140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nalyses</a:t>
            </a:r>
          </a:p>
        </p:txBody>
      </p:sp>
    </p:spTree>
    <p:extLst>
      <p:ext uri="{BB962C8B-B14F-4D97-AF65-F5344CB8AC3E}">
        <p14:creationId xmlns:p14="http://schemas.microsoft.com/office/powerpoint/2010/main" val="2877961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22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ary, Karen</dc:creator>
  <cp:lastModifiedBy>Yeary, Karen</cp:lastModifiedBy>
  <cp:revision>12</cp:revision>
  <dcterms:created xsi:type="dcterms:W3CDTF">2021-06-24T14:48:53Z</dcterms:created>
  <dcterms:modified xsi:type="dcterms:W3CDTF">2021-11-30T15:39:17Z</dcterms:modified>
</cp:coreProperties>
</file>